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416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537B17-3B57-4917-A77A-91A170B2C39D}" type="datetimeFigureOut">
              <a:rPr lang="en-US" smtClean="0"/>
              <a:t>10/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7B2FBA-388B-4753-A491-F852D4AB5E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71884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537B17-3B57-4917-A77A-91A170B2C39D}" type="datetimeFigureOut">
              <a:rPr lang="en-US" smtClean="0"/>
              <a:t>10/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7B2FBA-388B-4753-A491-F852D4AB5E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346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537B17-3B57-4917-A77A-91A170B2C39D}" type="datetimeFigureOut">
              <a:rPr lang="en-US" smtClean="0"/>
              <a:t>10/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7B2FBA-388B-4753-A491-F852D4AB5E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91680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537B17-3B57-4917-A77A-91A170B2C39D}" type="datetimeFigureOut">
              <a:rPr lang="en-US" smtClean="0"/>
              <a:t>10/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7B2FBA-388B-4753-A491-F852D4AB5E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24542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537B17-3B57-4917-A77A-91A170B2C39D}" type="datetimeFigureOut">
              <a:rPr lang="en-US" smtClean="0"/>
              <a:t>10/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7B2FBA-388B-4753-A491-F852D4AB5E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11938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537B17-3B57-4917-A77A-91A170B2C39D}" type="datetimeFigureOut">
              <a:rPr lang="en-US" smtClean="0"/>
              <a:t>10/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7B2FBA-388B-4753-A491-F852D4AB5E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49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537B17-3B57-4917-A77A-91A170B2C39D}" type="datetimeFigureOut">
              <a:rPr lang="en-US" smtClean="0"/>
              <a:t>10/5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7B2FBA-388B-4753-A491-F852D4AB5E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9259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537B17-3B57-4917-A77A-91A170B2C39D}" type="datetimeFigureOut">
              <a:rPr lang="en-US" smtClean="0"/>
              <a:t>10/5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7B2FBA-388B-4753-A491-F852D4AB5E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73037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537B17-3B57-4917-A77A-91A170B2C39D}" type="datetimeFigureOut">
              <a:rPr lang="en-US" smtClean="0"/>
              <a:t>10/5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7B2FBA-388B-4753-A491-F852D4AB5E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82910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537B17-3B57-4917-A77A-91A170B2C39D}" type="datetimeFigureOut">
              <a:rPr lang="en-US" smtClean="0"/>
              <a:t>10/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7B2FBA-388B-4753-A491-F852D4AB5E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79335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537B17-3B57-4917-A77A-91A170B2C39D}" type="datetimeFigureOut">
              <a:rPr lang="en-US" smtClean="0"/>
              <a:t>10/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7B2FBA-388B-4753-A491-F852D4AB5E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09200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537B17-3B57-4917-A77A-91A170B2C39D}" type="datetimeFigureOut">
              <a:rPr lang="en-US" smtClean="0"/>
              <a:t>10/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7B2FBA-388B-4753-A491-F852D4AB5E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3453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-14111" y="-71329"/>
            <a:ext cx="472722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S1A</a:t>
            </a:r>
            <a:r>
              <a:rPr lang="en-US" dirty="0"/>
              <a:t>: </a:t>
            </a:r>
            <a:r>
              <a:rPr lang="en-US" dirty="0" smtClean="0"/>
              <a:t>Feature Center, </a:t>
            </a:r>
            <a:r>
              <a:rPr lang="en-US" dirty="0" err="1" smtClean="0"/>
              <a:t>CpG</a:t>
            </a:r>
            <a:r>
              <a:rPr lang="en-US" dirty="0" smtClean="0"/>
              <a:t> Islands </a:t>
            </a:r>
            <a:r>
              <a:rPr lang="en-US" dirty="0" err="1" smtClean="0"/>
              <a:t>vs</a:t>
            </a:r>
            <a:r>
              <a:rPr lang="en-US" dirty="0" smtClean="0"/>
              <a:t> TFII-I</a:t>
            </a:r>
            <a:endParaRPr lang="en-US" dirty="0"/>
          </a:p>
          <a:p>
            <a:endParaRPr lang="en-US" dirty="0"/>
          </a:p>
        </p:txBody>
      </p:sp>
      <p:pic>
        <p:nvPicPr>
          <p:cNvPr id="5" name="Picture 4" descr="Screen shot 2014-09-22 at 11.24.27 AM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4111" y="342599"/>
            <a:ext cx="9144000" cy="1122004"/>
          </a:xfrm>
          <a:prstGeom prst="rect">
            <a:avLst/>
          </a:prstGeom>
        </p:spPr>
      </p:pic>
      <p:pic>
        <p:nvPicPr>
          <p:cNvPr id="6" name="Picture 5" descr="Screen shot 2014-09-22 at 11.24.42 AM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4111" y="1436381"/>
            <a:ext cx="9144000" cy="1795305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-1" y="3334428"/>
            <a:ext cx="30621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1B: ROI Center, TFII-I center 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355600" y="3985818"/>
            <a:ext cx="28284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FII-I </a:t>
            </a:r>
            <a:r>
              <a:rPr lang="en-US" dirty="0" err="1" smtClean="0"/>
              <a:t>vs</a:t>
            </a:r>
            <a:r>
              <a:rPr lang="en-US" dirty="0" smtClean="0"/>
              <a:t> </a:t>
            </a:r>
            <a:r>
              <a:rPr lang="en-US" dirty="0" err="1" smtClean="0"/>
              <a:t>Unmethylated</a:t>
            </a:r>
            <a:r>
              <a:rPr lang="en-US" dirty="0" smtClean="0"/>
              <a:t> </a:t>
            </a:r>
            <a:r>
              <a:rPr lang="en-US" dirty="0" err="1" smtClean="0"/>
              <a:t>CpGs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161845" y="3985819"/>
            <a:ext cx="25720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FII-I </a:t>
            </a:r>
            <a:r>
              <a:rPr lang="en-US" dirty="0" err="1" smtClean="0"/>
              <a:t>vs</a:t>
            </a:r>
            <a:r>
              <a:rPr lang="en-US" dirty="0" smtClean="0"/>
              <a:t> Methylated </a:t>
            </a:r>
            <a:r>
              <a:rPr lang="en-US" dirty="0" err="1" smtClean="0"/>
              <a:t>CpGs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3813751" y="4120484"/>
            <a:ext cx="10969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AMI  BMI</a:t>
            </a:r>
            <a:endParaRPr lang="en-US" sz="1200" dirty="0"/>
          </a:p>
        </p:txBody>
      </p:sp>
      <p:sp>
        <p:nvSpPr>
          <p:cNvPr id="12" name="TextBox 11"/>
          <p:cNvSpPr txBox="1"/>
          <p:nvPr/>
        </p:nvSpPr>
        <p:spPr>
          <a:xfrm>
            <a:off x="8315194" y="4120484"/>
            <a:ext cx="10969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AMI  BMI</a:t>
            </a:r>
            <a:endParaRPr lang="en-US" sz="1200" dirty="0"/>
          </a:p>
        </p:txBody>
      </p:sp>
      <p:pic>
        <p:nvPicPr>
          <p:cNvPr id="13" name="Picture 12" descr="Screen shot 2014-09-25 at 2.23.38 PM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464" y="4355152"/>
            <a:ext cx="4523314" cy="1968886"/>
          </a:xfrm>
          <a:prstGeom prst="rect">
            <a:avLst/>
          </a:prstGeom>
        </p:spPr>
      </p:pic>
      <p:pic>
        <p:nvPicPr>
          <p:cNvPr id="14" name="Picture 13" descr="Screen shot 2014-09-25 at 2.23.53 PM.png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11519" y="4355151"/>
            <a:ext cx="4523319" cy="19688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307264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29</Words>
  <Application>Microsoft Office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ryan</dc:creator>
  <cp:lastModifiedBy>mryan</cp:lastModifiedBy>
  <cp:revision>5</cp:revision>
  <dcterms:created xsi:type="dcterms:W3CDTF">2014-10-05T18:05:23Z</dcterms:created>
  <dcterms:modified xsi:type="dcterms:W3CDTF">2014-10-05T18:10:39Z</dcterms:modified>
</cp:coreProperties>
</file>